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1" r:id="rId3"/>
    <p:sldId id="257" r:id="rId4"/>
    <p:sldId id="262" r:id="rId5"/>
    <p:sldId id="263" r:id="rId6"/>
    <p:sldId id="264" r:id="rId7"/>
    <p:sldId id="265" r:id="rId8"/>
    <p:sldId id="266" r:id="rId9"/>
    <p:sldId id="305" r:id="rId10"/>
    <p:sldId id="306" r:id="rId11"/>
    <p:sldId id="307" r:id="rId12"/>
    <p:sldId id="308" r:id="rId13"/>
    <p:sldId id="309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311" r:id="rId22"/>
    <p:sldId id="312" r:id="rId23"/>
    <p:sldId id="313" r:id="rId24"/>
    <p:sldId id="314" r:id="rId25"/>
    <p:sldId id="316" r:id="rId26"/>
    <p:sldId id="317" r:id="rId27"/>
    <p:sldId id="318" r:id="rId28"/>
    <p:sldId id="315" r:id="rId29"/>
    <p:sldId id="274" r:id="rId30"/>
    <p:sldId id="286" r:id="rId31"/>
    <p:sldId id="284" r:id="rId32"/>
    <p:sldId id="285" r:id="rId33"/>
    <p:sldId id="275" r:id="rId34"/>
    <p:sldId id="276" r:id="rId35"/>
    <p:sldId id="277" r:id="rId36"/>
    <p:sldId id="278" r:id="rId37"/>
    <p:sldId id="287" r:id="rId38"/>
    <p:sldId id="288" r:id="rId39"/>
    <p:sldId id="289" r:id="rId40"/>
    <p:sldId id="290" r:id="rId41"/>
    <p:sldId id="280" r:id="rId42"/>
    <p:sldId id="281" r:id="rId43"/>
    <p:sldId id="282" r:id="rId44"/>
    <p:sldId id="283" r:id="rId45"/>
    <p:sldId id="291" r:id="rId46"/>
    <p:sldId id="293" r:id="rId47"/>
    <p:sldId id="322" r:id="rId48"/>
    <p:sldId id="321" r:id="rId49"/>
    <p:sldId id="320" r:id="rId50"/>
    <p:sldId id="319" r:id="rId51"/>
    <p:sldId id="292" r:id="rId52"/>
    <p:sldId id="294" r:id="rId53"/>
    <p:sldId id="295" r:id="rId54"/>
    <p:sldId id="296" r:id="rId55"/>
    <p:sldId id="297" r:id="rId56"/>
    <p:sldId id="298" r:id="rId57"/>
    <p:sldId id="299" r:id="rId58"/>
    <p:sldId id="300" r:id="rId59"/>
    <p:sldId id="302" r:id="rId60"/>
    <p:sldId id="303" r:id="rId61"/>
    <p:sldId id="304" r:id="rId62"/>
    <p:sldId id="301" r:id="rId63"/>
  </p:sldIdLst>
  <p:sldSz cx="9144000" cy="6858000" type="screen4x3"/>
  <p:notesSz cx="6887845" cy="1001839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12" userDrawn="1">
          <p15:clr>
            <a:srgbClr val="A4A3A4"/>
          </p15:clr>
        </p15:guide>
        <p15:guide id="2" pos="28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1" d="100"/>
          <a:sy n="91" d="100"/>
        </p:scale>
        <p:origin x="980" y="52"/>
      </p:cViewPr>
      <p:guideLst>
        <p:guide orient="horz" pos="2312"/>
        <p:guide pos="28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6" Type="http://schemas.openxmlformats.org/officeDocument/2006/relationships/tableStyles" Target="tableStyles.xml"/><Relationship Id="rId65" Type="http://schemas.openxmlformats.org/officeDocument/2006/relationships/viewProps" Target="viewProps.xml"/><Relationship Id="rId64" Type="http://schemas.openxmlformats.org/officeDocument/2006/relationships/presProps" Target="presProps.xml"/><Relationship Id="rId63" Type="http://schemas.openxmlformats.org/officeDocument/2006/relationships/slide" Target="slides/slide61.xml"/><Relationship Id="rId62" Type="http://schemas.openxmlformats.org/officeDocument/2006/relationships/slide" Target="slides/slide60.xml"/><Relationship Id="rId61" Type="http://schemas.openxmlformats.org/officeDocument/2006/relationships/slide" Target="slides/slide59.xml"/><Relationship Id="rId60" Type="http://schemas.openxmlformats.org/officeDocument/2006/relationships/slide" Target="slides/slide58.xml"/><Relationship Id="rId6" Type="http://schemas.openxmlformats.org/officeDocument/2006/relationships/slide" Target="slides/slide4.xml"/><Relationship Id="rId59" Type="http://schemas.openxmlformats.org/officeDocument/2006/relationships/slide" Target="slides/slide57.xml"/><Relationship Id="rId58" Type="http://schemas.openxmlformats.org/officeDocument/2006/relationships/slide" Target="slides/slide56.xml"/><Relationship Id="rId57" Type="http://schemas.openxmlformats.org/officeDocument/2006/relationships/slide" Target="slides/slide55.xml"/><Relationship Id="rId56" Type="http://schemas.openxmlformats.org/officeDocument/2006/relationships/slide" Target="slides/slide54.xml"/><Relationship Id="rId55" Type="http://schemas.openxmlformats.org/officeDocument/2006/relationships/slide" Target="slides/slide53.xml"/><Relationship Id="rId54" Type="http://schemas.openxmlformats.org/officeDocument/2006/relationships/slide" Target="slides/slide52.xml"/><Relationship Id="rId53" Type="http://schemas.openxmlformats.org/officeDocument/2006/relationships/slide" Target="slides/slide51.xml"/><Relationship Id="rId52" Type="http://schemas.openxmlformats.org/officeDocument/2006/relationships/slide" Target="slides/slide50.xml"/><Relationship Id="rId51" Type="http://schemas.openxmlformats.org/officeDocument/2006/relationships/slide" Target="slides/slide49.xml"/><Relationship Id="rId50" Type="http://schemas.openxmlformats.org/officeDocument/2006/relationships/slide" Target="slides/slide48.xml"/><Relationship Id="rId5" Type="http://schemas.openxmlformats.org/officeDocument/2006/relationships/slide" Target="slides/slide3.xml"/><Relationship Id="rId49" Type="http://schemas.openxmlformats.org/officeDocument/2006/relationships/slide" Target="slides/slide47.xml"/><Relationship Id="rId48" Type="http://schemas.openxmlformats.org/officeDocument/2006/relationships/slide" Target="slides/slide46.xml"/><Relationship Id="rId47" Type="http://schemas.openxmlformats.org/officeDocument/2006/relationships/slide" Target="slides/slide45.xml"/><Relationship Id="rId46" Type="http://schemas.openxmlformats.org/officeDocument/2006/relationships/slide" Target="slides/slide44.xml"/><Relationship Id="rId45" Type="http://schemas.openxmlformats.org/officeDocument/2006/relationships/slide" Target="slides/slide43.xml"/><Relationship Id="rId44" Type="http://schemas.openxmlformats.org/officeDocument/2006/relationships/slide" Target="slides/slide42.xml"/><Relationship Id="rId43" Type="http://schemas.openxmlformats.org/officeDocument/2006/relationships/slide" Target="slides/slide41.xml"/><Relationship Id="rId42" Type="http://schemas.openxmlformats.org/officeDocument/2006/relationships/slide" Target="slides/slide40.xml"/><Relationship Id="rId41" Type="http://schemas.openxmlformats.org/officeDocument/2006/relationships/slide" Target="slides/slide39.xml"/><Relationship Id="rId40" Type="http://schemas.openxmlformats.org/officeDocument/2006/relationships/slide" Target="slides/slide38.xml"/><Relationship Id="rId4" Type="http://schemas.openxmlformats.org/officeDocument/2006/relationships/slide" Target="slides/slide2.xml"/><Relationship Id="rId39" Type="http://schemas.openxmlformats.org/officeDocument/2006/relationships/slide" Target="slides/slide37.xml"/><Relationship Id="rId38" Type="http://schemas.openxmlformats.org/officeDocument/2006/relationships/slide" Target="slides/slide36.xml"/><Relationship Id="rId37" Type="http://schemas.openxmlformats.org/officeDocument/2006/relationships/slide" Target="slides/slide35.xml"/><Relationship Id="rId36" Type="http://schemas.openxmlformats.org/officeDocument/2006/relationships/slide" Target="slides/slide34.xml"/><Relationship Id="rId35" Type="http://schemas.openxmlformats.org/officeDocument/2006/relationships/slide" Target="slides/slide33.xml"/><Relationship Id="rId34" Type="http://schemas.openxmlformats.org/officeDocument/2006/relationships/slide" Target="slides/slide32.xml"/><Relationship Id="rId33" Type="http://schemas.openxmlformats.org/officeDocument/2006/relationships/slide" Target="slides/slide31.xml"/><Relationship Id="rId32" Type="http://schemas.openxmlformats.org/officeDocument/2006/relationships/slide" Target="slides/slide30.xml"/><Relationship Id="rId31" Type="http://schemas.openxmlformats.org/officeDocument/2006/relationships/slide" Target="slides/slide29.xml"/><Relationship Id="rId30" Type="http://schemas.openxmlformats.org/officeDocument/2006/relationships/slide" Target="slides/slide28.xml"/><Relationship Id="rId3" Type="http://schemas.openxmlformats.org/officeDocument/2006/relationships/slide" Target="slides/slide1.xml"/><Relationship Id="rId29" Type="http://schemas.openxmlformats.org/officeDocument/2006/relationships/slide" Target="slides/slide27.xml"/><Relationship Id="rId28" Type="http://schemas.openxmlformats.org/officeDocument/2006/relationships/slide" Target="slides/slide26.xml"/><Relationship Id="rId27" Type="http://schemas.openxmlformats.org/officeDocument/2006/relationships/slide" Target="slides/slide25.xml"/><Relationship Id="rId26" Type="http://schemas.openxmlformats.org/officeDocument/2006/relationships/slide" Target="slides/slide24.xml"/><Relationship Id="rId25" Type="http://schemas.openxmlformats.org/officeDocument/2006/relationships/slide" Target="slides/slide23.xml"/><Relationship Id="rId24" Type="http://schemas.openxmlformats.org/officeDocument/2006/relationships/slide" Target="slides/slide22.xml"/><Relationship Id="rId23" Type="http://schemas.openxmlformats.org/officeDocument/2006/relationships/slide" Target="slides/slide21.xml"/><Relationship Id="rId22" Type="http://schemas.openxmlformats.org/officeDocument/2006/relationships/slide" Target="slides/slide20.xml"/><Relationship Id="rId21" Type="http://schemas.openxmlformats.org/officeDocument/2006/relationships/slide" Target="slides/slide19.xml"/><Relationship Id="rId20" Type="http://schemas.openxmlformats.org/officeDocument/2006/relationships/slide" Target="slides/slide18.xml"/><Relationship Id="rId2" Type="http://schemas.openxmlformats.org/officeDocument/2006/relationships/theme" Target="theme/theme1.xml"/><Relationship Id="rId19" Type="http://schemas.openxmlformats.org/officeDocument/2006/relationships/slide" Target="slides/slide17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 hasCustomPrompt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 hasCustomPrompt="1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 hasCustomPrompt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 hasCustomPrompt="1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</p:txBody>
      </p:sp>
      <p:sp>
        <p:nvSpPr>
          <p:cNvPr id="6" name="내용 개체 틀 5"/>
          <p:cNvSpPr>
            <a:spLocks noGrp="1"/>
          </p:cNvSpPr>
          <p:nvPr>
            <p:ph sz="quarter" idx="4" hasCustomPrompt="1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E6B15-4E2E-40FF-BBA6-0EFD5F994143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95BBD-F69C-413D-BB69-DA5754EDFBDA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jpeg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2.tiff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3.tif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4.tiff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5.tiff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6.tiff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7.tiff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8.tiff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0.tiff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9.tiff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0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tiff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1.tiff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2.tiff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2.tiff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3.tiff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4.tiff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5.tiff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6.tiff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4.tiff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7.tiff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8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.tiff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9.tiff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0.tiff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1.tiff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2.tiff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3.tiff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4.tiff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5.tiff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6.tiff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7.tiff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8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.tiff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9.tiff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0.tiff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1.tiff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2.tiff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4.tiff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3.tiff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4.tiff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5.tiff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6.tiff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6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6.tiff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7.tiff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8.tiff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9.tiff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0.tiff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8.tiff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1.tiff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2.tiff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3.tiff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4.tiff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5.tif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7.tiff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6.tiff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2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9.png"/><Relationship Id="rId1" Type="http://schemas.openxmlformats.org/officeDocument/2006/relationships/image" Target="../media/image8.tif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0.tif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1" name="图片 20" descr="20220908_163129_00.22.650_8bit(7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31" r="11231" b="1451"/>
          <a:stretch>
            <a:fillRect/>
          </a:stretch>
        </p:blipFill>
        <p:spPr>
          <a:xfrm>
            <a:off x="35496" y="22039"/>
            <a:ext cx="2016224" cy="3069505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2267488" y="1155466"/>
            <a:ext cx="3772535" cy="368300"/>
          </a:xfrm>
          <a:prstGeom prst="rect">
            <a:avLst/>
          </a:prstGeom>
        </p:spPr>
        <p:txBody>
          <a:bodyPr wrap="none">
            <a:spAutoFit/>
          </a:bodyPr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8305C LPA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1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1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3058795" y="29254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058795" y="31800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3058795" y="35013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3060065" y="37541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3058795" y="4159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83485" y="3428365"/>
            <a:ext cx="3956685" cy="31686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07990" y="33826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1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24300" y="3068955"/>
            <a:ext cx="73342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LPAR1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2W5ZHD~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2267488" y="1155466"/>
            <a:ext cx="33623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2H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058795" y="28536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058795" y="31083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058795" y="33578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060065" y="36823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058795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770505" y="3341370"/>
            <a:ext cx="3956685" cy="3067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5507990" y="33826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3924300" y="2997200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2518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. TT</a:t>
            </a:r>
            <a:r>
              <a:rPr lang="en-US" altLang="ko-KR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i67</a:t>
            </a:r>
            <a:r>
              <a:rPr lang="en-US" altLang="zh-CN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nd size: 359 </a:t>
            </a:r>
            <a:r>
              <a:rPr lang="en-US" altLang="ko-KR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ko-KR" dirty="0" err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22GJW8~X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340" y="162941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32430" y="281305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31795" y="308737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931795" y="334518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931795" y="359854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2931795" y="396176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2205355"/>
            <a:ext cx="3956685" cy="27305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652135" y="2179320"/>
            <a:ext cx="7454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9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23665" y="1884045"/>
            <a:ext cx="53848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i67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931795" y="257619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0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2931795" y="2452370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915285" y="226504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933065" y="428561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2H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578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6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2H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9A9MG~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87040" y="27813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85770" y="3143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987040" y="343471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87040" y="37611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987040" y="4087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 rot="21120000">
            <a:off x="2487930" y="3315335"/>
            <a:ext cx="3893185" cy="28829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79745" y="31076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80790" y="2925445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40182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8305C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YRCNJ~D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5702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30550" y="26377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2927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130550" y="32194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130550" y="34740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8004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987675" y="3171190"/>
            <a:ext cx="3893185" cy="2832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3127375"/>
            <a:ext cx="521335" cy="39878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24300" y="2853690"/>
            <a:ext cx="53848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42214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8305C p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TV3ZF~L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29280" y="26377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29019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129280" y="31794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129280" y="34290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29280" y="38004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630170" y="3145790"/>
            <a:ext cx="3893185" cy="2832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80380" y="3087370"/>
            <a:ext cx="521335" cy="39878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</a:t>
            </a: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2780665"/>
            <a:ext cx="68643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237Z5P~G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83485" y="1557020"/>
            <a:ext cx="4320000" cy="3535276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2267488" y="1155466"/>
            <a:ext cx="35610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8305C 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2843530" y="27813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842260" y="3071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843530" y="336296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842260" y="36449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843530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5875" y="3297555"/>
            <a:ext cx="3893185" cy="2832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2512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09035" y="2997200"/>
            <a:ext cx="57785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2VDIZI~R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2267488" y="1155466"/>
            <a:ext cx="37642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8305C p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3129280" y="29248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31889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129280" y="34956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131820" y="38614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5875" y="3501390"/>
            <a:ext cx="3893185" cy="2832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4664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3067685"/>
            <a:ext cx="72580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2TBZNK~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98370" y="1557020"/>
            <a:ext cx="4320000" cy="3535276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2267488" y="1155466"/>
            <a:ext cx="38195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8305C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2626995" y="25654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626995" y="2856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628265" y="31076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628265" y="34023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628265" y="37287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 rot="21360000">
            <a:off x="2339975" y="3053080"/>
            <a:ext cx="3893185" cy="2578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07990" y="29178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493770" y="2710180"/>
            <a:ext cx="67754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6245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D103W~B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85770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85770" y="2944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987040" y="32512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87040" y="34740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987040" y="38004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 rot="21360000">
            <a:off x="2695575" y="3150235"/>
            <a:ext cx="3893185" cy="27686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80380" y="3015615"/>
            <a:ext cx="521335" cy="39878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852545" y="2853690"/>
            <a:ext cx="53848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8277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28LXAL~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051685" y="166179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626995" y="29965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626995" y="32131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626995" y="34956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629535" y="37896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267585" y="3440430"/>
            <a:ext cx="3893185" cy="2832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149215" y="3394710"/>
            <a:ext cx="521335" cy="39878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565525" y="3067685"/>
            <a:ext cx="68643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 descr="20220705_095636_00.00.227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95755"/>
            <a:ext cx="4320000" cy="3535276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2267488" y="1155466"/>
            <a:ext cx="37560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8305C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1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3202305" y="27101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202305" y="296481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202305" y="32912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202305" y="36175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202305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11730" y="3335020"/>
            <a:ext cx="3893185" cy="26670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79745" y="33108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2925445"/>
            <a:ext cx="67754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1673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5GZSF~W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62877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770505" y="27806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770505" y="3016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771775" y="32512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771775" y="34740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14905" y="3251835"/>
            <a:ext cx="3893185" cy="27305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364480" y="32048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852545" y="2853690"/>
            <a:ext cx="56832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705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-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AIDT5~J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95830" y="162877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698750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698750" y="30880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700020" y="33572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700020" y="36175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339975" y="3357245"/>
            <a:ext cx="3893185" cy="25082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363845" y="33108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493770" y="2853690"/>
            <a:ext cx="72580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623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5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2W5ZHD~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67585" y="155702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14015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14015" y="3143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15285" y="33947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15285" y="37611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915285" y="4087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626995" y="3411855"/>
            <a:ext cx="3893185" cy="2578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95010" y="33826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80790" y="2997200"/>
            <a:ext cx="67754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6201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2C71AS~W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95830" y="170116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770505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770505" y="3143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771775" y="33947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771775" y="36893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771775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11730" y="3232150"/>
            <a:ext cx="3893185" cy="37338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364480" y="3230880"/>
            <a:ext cx="521335" cy="39878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637280" y="2925445"/>
            <a:ext cx="54864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8233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-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2C3UYZ~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67585" y="155702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85770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85770" y="2999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87040" y="32512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87040" y="35458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987040" y="3872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626995" y="3251835"/>
            <a:ext cx="3893185" cy="2578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651500" y="3167380"/>
            <a:ext cx="521335" cy="39878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zh-CN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</a:t>
            </a: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zh-CN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</a:t>
            </a: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852545" y="2925445"/>
            <a:ext cx="68643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15849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TT 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25HHGC~X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67585" y="170116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770505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770505" y="3143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771775" y="33947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771775" y="36893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771775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11730" y="3395345"/>
            <a:ext cx="3893185" cy="2578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33826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637280" y="3068955"/>
            <a:ext cx="57785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6169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TT p-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2XLIDP~B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66116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057525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057525" y="2999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058795" y="32512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058795" y="35458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058795" y="3872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698750" y="3251835"/>
            <a:ext cx="3893185" cy="2578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2391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24300" y="2925445"/>
            <a:ext cx="57785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623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5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3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29A9MG~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67585" y="162877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14015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14015" y="32150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15285" y="35382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15285" y="383286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915285" y="42310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 rot="21180000">
            <a:off x="2559685" y="3395345"/>
            <a:ext cx="3893185" cy="33147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80380" y="328485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80790" y="3068955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7725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8305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LPA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1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0819_160531_02.28.515_8bit(4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29280" y="263715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2927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130550" y="32512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130550" y="35458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872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0505" y="3180080"/>
            <a:ext cx="3893185" cy="34544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651500" y="32391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1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96055" y="2925445"/>
            <a:ext cx="73342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LPAR1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7560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8305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20220816_222553_00.16.001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057525" y="27806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057525" y="3071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058795" y="33947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058795" y="37611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058795" y="4087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698750" y="3348990"/>
            <a:ext cx="3893185" cy="32956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79745" y="33108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24300" y="2925445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78835" cy="368300"/>
          </a:xfrm>
          <a:prstGeom prst="rect">
            <a:avLst/>
          </a:prstGeom>
        </p:spPr>
        <p:txBody>
          <a:bodyPr wrap="none">
            <a:spAutoFit/>
          </a:bodyPr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K1 LPA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1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1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20220908_155407_00.08.517_8bit(7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5702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15285" y="29254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15285" y="32131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915285" y="35064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915285" y="38677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2915285" y="4159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339975" y="3500120"/>
            <a:ext cx="3956685" cy="27305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364480" y="34544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1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80790" y="3140710"/>
            <a:ext cx="73342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LPAR1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3788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LPA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1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1_20220616_211449_00.31.763_8bit(7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201035" y="24218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201035" y="263715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202305" y="28924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202305" y="32238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202305" y="351345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00020" y="2865755"/>
            <a:ext cx="3893185" cy="2489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288036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1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2494915"/>
            <a:ext cx="73342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LPAR1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3623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0803_165905_00.01.638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201035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201035" y="32111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202305" y="35382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202305" y="37979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202305" y="4159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3460115"/>
            <a:ext cx="3893185" cy="32258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4544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24300" y="3140710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37439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5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LPA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1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029_101101_00.01.283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29280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29959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130550" y="332295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5826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130550" y="3943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625090" y="3303270"/>
            <a:ext cx="3893185" cy="32258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077460" y="33108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1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852545" y="2925445"/>
            <a:ext cx="73342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LPAR1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6210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3578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6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0914_181911_00.15.221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703320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703320" y="29959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704590" y="32880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704590" y="35826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704590" y="3943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3288030"/>
            <a:ext cx="3893185" cy="27940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2391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426585" y="2925445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6499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8305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Ki67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359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206_162740_00.01.456_8bit(4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059430" y="253301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30550" y="280733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3202305" y="306514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3202305" y="331851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3202305" y="368173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5875" y="1873250"/>
            <a:ext cx="3956685" cy="31750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1891665"/>
            <a:ext cx="7454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9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07765" y="1596390"/>
            <a:ext cx="53848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i67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987040" y="2296160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0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87040" y="217233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70530" y="1985010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203575" y="400558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7560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8305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7_165148_00.03.880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842260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842260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843530" y="32162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843530" y="351091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843530" y="3872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84755" y="3216275"/>
            <a:ext cx="3893185" cy="27940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31673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80790" y="2853690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2562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Ki67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359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206_160637_00.01.922_8bit(7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059430" y="271907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058795" y="299339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3058795" y="332295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3058795" y="357632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3058795" y="393954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5875" y="2059305"/>
            <a:ext cx="3956685" cy="3448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2077720"/>
            <a:ext cx="7454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9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07765" y="1782445"/>
            <a:ext cx="53848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i67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987040" y="248221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0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87040" y="2358390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70530" y="217106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060065" y="426339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3623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0929_191120_00.00.920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29280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31394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130550" y="34315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7979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130550" y="4159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3456305"/>
            <a:ext cx="3893185" cy="30099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4544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3140710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2518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5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Ki67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180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206_155827_00.03.613_8bit(4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059430" y="279082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058795" y="306514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3063240" y="328549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3063240" y="353885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3131820" y="395922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5875" y="2059305"/>
            <a:ext cx="3956685" cy="3448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2077720"/>
            <a:ext cx="7454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9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07765" y="1782445"/>
            <a:ext cx="53848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i67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987040" y="248221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0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87040" y="2358390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70530" y="217106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3090" y="428307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3623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6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0929_191800_00.02.999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8348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29280" y="263715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130550" y="32162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5826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130550" y="3943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3241040"/>
            <a:ext cx="3893185" cy="30099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2391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2925445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1_20220425_105243_00.01.267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2267488" y="1155466"/>
            <a:ext cx="34258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K1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1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2413000" y="27095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411730" y="2999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413000" y="32912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413000" y="36175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413000" y="3943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11730" y="3300095"/>
            <a:ext cx="3893185" cy="2578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364480" y="32512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206750" y="2925445"/>
            <a:ext cx="67754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91133" y="332656"/>
            <a:ext cx="92456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J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40182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8305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30_155048_00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29280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31394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130550" y="33597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6544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130550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3303905"/>
            <a:ext cx="3893185" cy="3625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652135" y="3284855"/>
            <a:ext cx="589280" cy="46037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</a:t>
            </a:r>
            <a:r>
              <a:rPr lang="en-US" altLang="zh-CN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zh-CN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2997200"/>
            <a:ext cx="70675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91133" y="332656"/>
            <a:ext cx="92456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J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42214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8305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-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30_161347_00.00.975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29280" y="27806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30676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130550" y="32880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5826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130550" y="3943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3293745"/>
            <a:ext cx="3893185" cy="30099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652135" y="3213100"/>
            <a:ext cx="589280" cy="46037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</a:t>
            </a:r>
            <a:r>
              <a:rPr lang="en-US" altLang="zh-CN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zh-CN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2925445"/>
            <a:ext cx="70675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91133" y="332656"/>
            <a:ext cx="92456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J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5610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8305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9_141734_00.01.186_8bit(7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698750" y="24936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698750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700020" y="292925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700020" y="32238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700020" y="35852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341245" y="2988945"/>
            <a:ext cx="3893185" cy="24701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292725" y="29248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637280" y="2566670"/>
            <a:ext cx="57785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직사각형 8"/>
          <p:cNvSpPr/>
          <p:nvPr/>
        </p:nvSpPr>
        <p:spPr>
          <a:xfrm>
            <a:off x="7691133" y="332656"/>
            <a:ext cx="92456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J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267488" y="1155466"/>
            <a:ext cx="37642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8305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-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9_141221_00.00.244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201035" y="25654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201035" y="27806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202305" y="30010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202305" y="32956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202305" y="36569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843530" y="3060700"/>
            <a:ext cx="3893185" cy="24701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95010" y="29965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139565" y="2638425"/>
            <a:ext cx="72580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7560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8305C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7_165148_00.03.880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24000"/>
            <a:ext cx="4320000" cy="3535276"/>
          </a:xfrm>
          <a:prstGeom prst="rect">
            <a:avLst/>
          </a:prstGeom>
          <a:ln w="60325" cmpd="sng">
            <a:noFill/>
            <a:prstDash val="solid"/>
          </a:ln>
        </p:spPr>
      </p:pic>
      <p:sp>
        <p:nvSpPr>
          <p:cNvPr id="9" name="직사각형 8"/>
          <p:cNvSpPr/>
          <p:nvPr/>
        </p:nvSpPr>
        <p:spPr>
          <a:xfrm>
            <a:off x="7691133" y="332656"/>
            <a:ext cx="92456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J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2842260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842260" y="29959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843530" y="32162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843530" y="351091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843530" y="3872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84755" y="3237230"/>
            <a:ext cx="3893185" cy="23304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32042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80790" y="2853690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1419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3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K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23_174601_00.00.601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770505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770505" y="31457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771775" y="34315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771775" y="37261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771775" y="4087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13000" y="3416935"/>
            <a:ext cx="3893185" cy="2686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364480" y="34194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3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09035" y="3068955"/>
            <a:ext cx="54864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451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-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3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K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23_172036_00.00.348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23440" y="170116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626995" y="27806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626995" y="30022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628265" y="32880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628265" y="35826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628265" y="3943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269490" y="3273425"/>
            <a:ext cx="3893185" cy="2686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220970" y="32759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3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565525" y="2925445"/>
            <a:ext cx="68643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1673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K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30_155737_00.02.373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55829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842260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842260" y="30740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843530" y="33597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843530" y="36544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843530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84755" y="3345180"/>
            <a:ext cx="3893185" cy="2686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33477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80790" y="2997200"/>
            <a:ext cx="57785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705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-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K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30_162526_00.01.273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5829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29280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31457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130550" y="34315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7261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130550" y="4087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3373120"/>
            <a:ext cx="3893185" cy="3124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4194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3068955"/>
            <a:ext cx="72580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623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5. K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K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0929_191120_00.00.920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55765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057525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057525" y="32111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058795" y="35032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058795" y="37979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058795" y="4159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00020" y="3524250"/>
            <a:ext cx="3893185" cy="23304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651500" y="3491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96055" y="3140710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69945" cy="368300"/>
          </a:xfrm>
          <a:prstGeom prst="rect">
            <a:avLst/>
          </a:prstGeom>
        </p:spPr>
        <p:txBody>
          <a:bodyPr wrap="none">
            <a:spAutoFit/>
          </a:bodyPr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TT LPA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1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1E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05_183418_00.08.264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204845" y="240601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203575" y="26962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204845" y="29159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204845" y="32423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204845" y="35687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 rot="300000">
            <a:off x="3204845" y="3083560"/>
            <a:ext cx="3893185" cy="2578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6011545" y="31413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1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357370" y="2693670"/>
            <a:ext cx="73342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LPAR1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5566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86053" y="332656"/>
            <a:ext cx="93472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L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203_140706_00.04.394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14015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14015" y="29959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15920" y="32353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915285" y="351091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915285" y="3872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6510" y="3077845"/>
            <a:ext cx="3893185" cy="40068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07990" y="3020060"/>
            <a:ext cx="656590" cy="52197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852545" y="2710180"/>
            <a:ext cx="54864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8233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-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86053" y="332656"/>
            <a:ext cx="93472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L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30_150113_00.02.015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057525" y="263715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057525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058795" y="31445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058795" y="343916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058795" y="38004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00020" y="2983865"/>
            <a:ext cx="3893185" cy="41465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651500" y="2943860"/>
            <a:ext cx="656590" cy="52197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96055" y="2781935"/>
            <a:ext cx="70675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1629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86053" y="332656"/>
            <a:ext cx="93472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L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203_141114_00.00.476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85770" y="27806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85770" y="30022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87040" y="32880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987040" y="35826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987040" y="3943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628265" y="3308985"/>
            <a:ext cx="3893185" cy="23304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579745" y="327596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24300" y="2925445"/>
            <a:ext cx="57785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661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-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86053" y="332656"/>
            <a:ext cx="93472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L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23_180154_00.00.254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0460" y="162941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842260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842260" y="30740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843530" y="33597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843530" y="36544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843530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84755" y="3380740"/>
            <a:ext cx="3893185" cy="23304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33477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80790" y="2997200"/>
            <a:ext cx="72580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3578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5. TT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86053" y="332656"/>
            <a:ext cx="93472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4L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20220929_191800_00.02.999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555875" y="1772920"/>
            <a:ext cx="4320000" cy="3535276"/>
          </a:xfrm>
          <a:prstGeom prst="rect">
            <a:avLst/>
          </a:prstGeom>
          <a:ln w="53975">
            <a:noFill/>
          </a:ln>
        </p:spPr>
      </p:pic>
      <p:sp>
        <p:nvSpPr>
          <p:cNvPr id="10" name="矩形 9"/>
          <p:cNvSpPr/>
          <p:nvPr/>
        </p:nvSpPr>
        <p:spPr>
          <a:xfrm>
            <a:off x="3129280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32111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130550" y="35032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79793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3130550" y="41592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3524250"/>
            <a:ext cx="3893185" cy="27305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491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067810" y="3140710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29133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i67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359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5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20221119_144927_00.11.184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83485" y="158940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628265" y="322516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627630" y="349948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627630" y="390080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2627630" y="430212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83485" y="2466340"/>
            <a:ext cx="3956685" cy="27305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694680" y="2466340"/>
            <a:ext cx="7454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9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491865" y="2145030"/>
            <a:ext cx="53848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i67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555875" y="306006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0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2555875" y="286448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539365" y="2677160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0194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5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9_154028_00.01.951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77292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626995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626995" y="31394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628265" y="33597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628265" y="36544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628265" y="387223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6510" y="3385820"/>
            <a:ext cx="3893185" cy="26797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95010" y="33477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565525" y="2997200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27990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7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6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9_143258_00.04.261_8bit(7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66116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555240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555240" y="31394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556510" y="33597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556510" y="36544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556510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6510" y="3429635"/>
            <a:ext cx="3893185" cy="26797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3493770" y="3068955"/>
            <a:ext cx="54864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5724525" y="3374390"/>
            <a:ext cx="656590" cy="294640"/>
          </a:xfrm>
          <a:prstGeom prst="rect">
            <a:avLst/>
          </a:prstGeom>
        </p:spPr>
        <p:txBody>
          <a:bodyPr wrap="none" rtlCol="0">
            <a:noAutofit/>
          </a:bodyPr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</a:t>
            </a: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0022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p-ER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7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6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9_142451_00.03.951_8bit(7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67585" y="170116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483485" y="30676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483485" y="33547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484755" y="357505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484755" y="386969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484755" y="42310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414905" y="3575050"/>
            <a:ext cx="3893185" cy="32766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651500" y="3575050"/>
            <a:ext cx="656590" cy="294640"/>
          </a:xfrm>
          <a:prstGeom prst="rect">
            <a:avLst/>
          </a:prstGeom>
        </p:spPr>
        <p:txBody>
          <a:bodyPr wrap="none" rtlCol="0">
            <a:noAutofit/>
          </a:bodyPr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4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</a:t>
            </a:r>
            <a:r>
              <a:rPr lang="en-US" altLang="ko-KR" sz="10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0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422015" y="3284220"/>
            <a:ext cx="68643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ER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28244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6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9_142828_00.00.373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095" y="163131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770505" y="28524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770505" y="31127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771775" y="33597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771775" y="36544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771775" y="40157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771775" y="3388995"/>
            <a:ext cx="3893185" cy="30861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938520" y="34194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09035" y="3068955"/>
            <a:ext cx="57785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41693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TT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1E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028_134413_00.01.893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1730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130550" y="278130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129280" y="3071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130550" y="32912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130550" y="36175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130550" y="394398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 rot="21420000">
            <a:off x="2994660" y="3256915"/>
            <a:ext cx="3581400" cy="24701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1794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924300" y="2925445"/>
            <a:ext cx="67754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0276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p-MEK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5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6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9_142111_00.00.215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340" y="155829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555240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555240" y="31394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556510" y="343154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556510" y="372618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556510" y="408749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6510" y="3429635"/>
            <a:ext cx="3893185" cy="26797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4194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493770" y="3068955"/>
            <a:ext cx="725805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-MEK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0194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6211" y="332656"/>
            <a:ext cx="954405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6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0221119_154028_00.01.951_8bit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557655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555240" y="270891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555240" y="292417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556510" y="31445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556510" y="343916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556510" y="37287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6510" y="3182620"/>
            <a:ext cx="3893185" cy="22796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723255" y="313245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493770" y="2781935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6499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8305C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i67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359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2H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OGB24~C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39975" y="1524000"/>
            <a:ext cx="4320000" cy="353527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987675" y="274828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87040" y="302260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987040" y="328041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987040" y="353377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2987040" y="389699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555875" y="2132965"/>
            <a:ext cx="3956685" cy="27305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5436235" y="2106930"/>
            <a:ext cx="7454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9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707765" y="1811655"/>
            <a:ext cx="53848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i67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987040" y="251142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0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87040" y="2387600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70530" y="220027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850" y="260985"/>
            <a:ext cx="1009650" cy="3924300"/>
          </a:xfrm>
          <a:prstGeom prst="rect">
            <a:avLst/>
          </a:prstGeom>
        </p:spPr>
      </p:pic>
      <p:sp>
        <p:nvSpPr>
          <p:cNvPr id="11" name="矩形 10"/>
          <p:cNvSpPr/>
          <p:nvPr/>
        </p:nvSpPr>
        <p:spPr>
          <a:xfrm>
            <a:off x="2988310" y="422084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756025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8305C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42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2H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2TBZNK~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57020"/>
            <a:ext cx="4320000" cy="3535276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843530" y="256667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843530" y="282130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843530" y="307086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844800" y="339534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843530" y="3728720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555240" y="3054350"/>
            <a:ext cx="3956685" cy="30670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5292725" y="3095625"/>
            <a:ext cx="6565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3709035" y="2710180"/>
            <a:ext cx="7200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직사각형 6"/>
          <p:cNvSpPr/>
          <p:nvPr/>
        </p:nvSpPr>
        <p:spPr>
          <a:xfrm>
            <a:off x="2267488" y="1155466"/>
            <a:ext cx="3256280" cy="368300"/>
          </a:xfrm>
          <a:prstGeom prst="rect">
            <a:avLst/>
          </a:prstGeom>
        </p:spPr>
        <p:txBody>
          <a:bodyPr wrap="none">
            <a:spAutoFit/>
          </a:bodyPr>
          <a:p>
            <a:pPr algn="l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3. K1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i67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band size: 359 </a:t>
            </a: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671448" y="332656"/>
            <a:ext cx="963930" cy="306705"/>
          </a:xfrm>
          <a:prstGeom prst="rect">
            <a:avLst/>
          </a:prstGeom>
        </p:spPr>
        <p:txBody>
          <a:bodyPr wrap="none">
            <a:spAutoFit/>
          </a:bodyPr>
          <a:p>
            <a:pPr algn="ctr"/>
            <a:r>
              <a:rPr lang="en-US" altLang="ko-KR" sz="1400" dirty="0">
                <a:latin typeface="Arial" panose="020B0604020202020204" pitchFamily="34" charset="0"/>
                <a:ea typeface="Adobe 宋体 Std L" panose="02020300000000000000" pitchFamily="18" charset="-122"/>
                <a:cs typeface="Arial" panose="020B0604020202020204" pitchFamily="34" charset="0"/>
              </a:rPr>
              <a:t>Figure 2H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2IORRL~B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2365" y="1524000"/>
            <a:ext cx="4320000" cy="3535276"/>
          </a:xfrm>
          <a:prstGeom prst="rect">
            <a:avLst/>
          </a:prstGeom>
        </p:spPr>
      </p:pic>
      <p:sp>
        <p:nvSpPr>
          <p:cNvPr id="22" name="矩形 21"/>
          <p:cNvSpPr/>
          <p:nvPr/>
        </p:nvSpPr>
        <p:spPr>
          <a:xfrm>
            <a:off x="2700020" y="2015490"/>
            <a:ext cx="3956685" cy="32639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5436235" y="2035175"/>
            <a:ext cx="74549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9kDa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3636010" y="1713865"/>
            <a:ext cx="538480" cy="306705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4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i67</a:t>
            </a:r>
            <a:endParaRPr lang="en-US" altLang="ko-KR" sz="14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2987675" y="274828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987040" y="302260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987040" y="3280410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4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987040" y="353377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3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2987040" y="389699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2987040" y="251142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0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987040" y="2315845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970530" y="2128520"/>
            <a:ext cx="6654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250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988310" y="4220845"/>
            <a:ext cx="589280" cy="275590"/>
          </a:xfrm>
          <a:prstGeom prst="rect">
            <a:avLst/>
          </a:prstGeom>
        </p:spPr>
        <p:txBody>
          <a:bodyPr wrap="non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ko-KR" sz="1200" dirty="0">
                <a:solidFill>
                  <a:srgbClr val="FFFF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5kDa</a:t>
            </a:r>
            <a:endParaRPr lang="en-US" altLang="ko-KR" sz="1200" dirty="0">
              <a:solidFill>
                <a:srgbClr val="FFFF00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33</Words>
  <Application>WPS 演示</Application>
  <PresentationFormat>全屏显示(4:3)</PresentationFormat>
  <Paragraphs>1154</Paragraphs>
  <Slides>6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1</vt:i4>
      </vt:variant>
    </vt:vector>
  </HeadingPairs>
  <TitlesOfParts>
    <vt:vector size="71" baseType="lpstr">
      <vt:lpstr>Arial</vt:lpstr>
      <vt:lpstr>宋体</vt:lpstr>
      <vt:lpstr>Wingdings</vt:lpstr>
      <vt:lpstr>Adobe 宋体 Std L</vt:lpstr>
      <vt:lpstr>Times New Roman</vt:lpstr>
      <vt:lpstr>Malgun Gothic</vt:lpstr>
      <vt:lpstr>微软雅黑</vt:lpstr>
      <vt:lpstr>Arial Unicode MS</vt:lpstr>
      <vt:lpstr>Calibri</vt:lpstr>
      <vt:lpstr>Office 테마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PS_1652076839</cp:lastModifiedBy>
  <cp:revision>39</cp:revision>
  <cp:lastPrinted>2022-12-14T05:58:00Z</cp:lastPrinted>
  <dcterms:created xsi:type="dcterms:W3CDTF">2022-12-13T06:36:00Z</dcterms:created>
  <dcterms:modified xsi:type="dcterms:W3CDTF">2025-01-18T01:59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E52D6453DA64686B0020F30C227331D_13</vt:lpwstr>
  </property>
  <property fmtid="{D5CDD505-2E9C-101B-9397-08002B2CF9AE}" pid="3" name="KSOProductBuildVer">
    <vt:lpwstr>2052-12.1.0.19770</vt:lpwstr>
  </property>
</Properties>
</file>